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884" autoAdjust="0"/>
  </p:normalViewPr>
  <p:slideViewPr>
    <p:cSldViewPr snapToGrid="0">
      <p:cViewPr varScale="1">
        <p:scale>
          <a:sx n="97" d="100"/>
          <a:sy n="97" d="100"/>
        </p:scale>
        <p:origin x="107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78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872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88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188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405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403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350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411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330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49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80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2EA70-05CD-46C1-82C7-F883E0B18400}" type="datetimeFigureOut">
              <a:rPr lang="en-US" smtClean="0"/>
              <a:t>8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C5659-2CD5-4A8B-B1EF-2A85B81DDE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36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563" y="252792"/>
            <a:ext cx="4344684" cy="23385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22770" y="-3768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3-compartment </a:t>
            </a:r>
            <a:r>
              <a:rPr lang="en-US" dirty="0" smtClean="0"/>
              <a:t>model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037" y="2591324"/>
            <a:ext cx="4439210" cy="226746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4563" y="4858791"/>
            <a:ext cx="4264002" cy="199287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400587" y="-3768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2-compartment </a:t>
            </a:r>
            <a:r>
              <a:rPr lang="en-US" dirty="0" smtClean="0"/>
              <a:t>model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59212" y="369332"/>
            <a:ext cx="4323551" cy="222199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37678" y="2663916"/>
            <a:ext cx="4245085" cy="218598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09392" y="4849904"/>
            <a:ext cx="4091807" cy="1971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7309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337" y="3857869"/>
            <a:ext cx="2340628" cy="263752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6337" y="937374"/>
            <a:ext cx="2488546" cy="2551636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6824" y="904880"/>
            <a:ext cx="2734681" cy="261234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8541" y="3748576"/>
            <a:ext cx="2345707" cy="261636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716337" y="200831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3-compartment </a:t>
            </a:r>
            <a:r>
              <a:rPr lang="en-US" dirty="0" smtClean="0"/>
              <a:t>model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688541" y="205599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2-compartment </a:t>
            </a:r>
            <a:r>
              <a:rPr lang="en-US" dirty="0" smtClean="0"/>
              <a:t>mod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3115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9857" y="1018334"/>
            <a:ext cx="9848850" cy="42862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9857" y="3195330"/>
            <a:ext cx="9820275" cy="4476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22867" y="561197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3-compartment </a:t>
            </a:r>
            <a:r>
              <a:rPr lang="en-US" dirty="0" smtClean="0"/>
              <a:t>model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022867" y="2738193"/>
            <a:ext cx="288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itial 2-compartment </a:t>
            </a:r>
            <a:r>
              <a:rPr lang="en-US" dirty="0" smtClean="0"/>
              <a:t>mod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3029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18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KSU College Of Veterinary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meng Lin</dc:creator>
  <cp:lastModifiedBy>Zhoumeng Lin</cp:lastModifiedBy>
  <cp:revision>7</cp:revision>
  <dcterms:created xsi:type="dcterms:W3CDTF">2016-08-12T14:08:52Z</dcterms:created>
  <dcterms:modified xsi:type="dcterms:W3CDTF">2016-08-13T20:30:34Z</dcterms:modified>
</cp:coreProperties>
</file>